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27" userDrawn="1">
          <p15:clr>
            <a:srgbClr val="A4A3A4"/>
          </p15:clr>
        </p15:guide>
        <p15:guide id="2" pos="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A557"/>
    <a:srgbClr val="3DCC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54"/>
    <p:restoredTop sz="86226"/>
  </p:normalViewPr>
  <p:slideViewPr>
    <p:cSldViewPr snapToGrid="0" snapToObjects="1" showGuides="1">
      <p:cViewPr varScale="1">
        <p:scale>
          <a:sx n="38" d="100"/>
          <a:sy n="38" d="100"/>
        </p:scale>
        <p:origin x="2544" y="40"/>
      </p:cViewPr>
      <p:guideLst>
        <p:guide orient="horz" pos="6227"/>
        <p:guide pos="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78F303-2E4E-6B4C-897F-D86FA82B0AFC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57F82D-6121-1248-8497-3B8C72E67E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185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57F82D-6121-1248-8497-3B8C72E67E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2496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78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11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098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7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08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699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593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876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172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672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415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01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A51DB78-C4F5-9D4B-A6F6-CA9260C805D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533" b="7383"/>
          <a:stretch/>
        </p:blipFill>
        <p:spPr>
          <a:xfrm>
            <a:off x="5343258" y="615088"/>
            <a:ext cx="1380137" cy="1526961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3B357555-A751-624B-8896-2B08173287D2}"/>
              </a:ext>
            </a:extLst>
          </p:cNvPr>
          <p:cNvGrpSpPr/>
          <p:nvPr/>
        </p:nvGrpSpPr>
        <p:grpSpPr>
          <a:xfrm>
            <a:off x="235594" y="603377"/>
            <a:ext cx="5096739" cy="1479496"/>
            <a:chOff x="311112" y="1866765"/>
            <a:chExt cx="5096739" cy="147949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E8B991E9-0DE6-0540-ABAC-CE8E998481CC}"/>
                </a:ext>
              </a:extLst>
            </p:cNvPr>
            <p:cNvGrpSpPr/>
            <p:nvPr/>
          </p:nvGrpSpPr>
          <p:grpSpPr>
            <a:xfrm>
              <a:off x="311112" y="2058306"/>
              <a:ext cx="5096739" cy="1287955"/>
              <a:chOff x="474479" y="1831277"/>
              <a:chExt cx="5096739" cy="1287955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51185EF7-B4F6-C04E-9AB1-B7366CDFAE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7113" b="2892"/>
              <a:stretch/>
            </p:blipFill>
            <p:spPr>
              <a:xfrm>
                <a:off x="4262348" y="1840907"/>
                <a:ext cx="1308870" cy="1272653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D184C970-0658-9647-B60C-4CC431A40A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165" b="4198"/>
              <a:stretch/>
            </p:blipFill>
            <p:spPr>
              <a:xfrm>
                <a:off x="3010192" y="1832999"/>
                <a:ext cx="1241231" cy="1280561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8F72EBD9-34A8-F54A-B22A-C7B2AC9982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7151" b="8914"/>
              <a:stretch/>
            </p:blipFill>
            <p:spPr>
              <a:xfrm>
                <a:off x="1728519" y="1836556"/>
                <a:ext cx="1249406" cy="1282676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6CB52F9F-5877-2A46-8108-9A60599E18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4825" b="11277"/>
              <a:stretch/>
            </p:blipFill>
            <p:spPr>
              <a:xfrm>
                <a:off x="474479" y="1831277"/>
                <a:ext cx="1276782" cy="1282283"/>
              </a:xfrm>
              <a:prstGeom prst="rect">
                <a:avLst/>
              </a:prstGeom>
            </p:spPr>
          </p:pic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143A404-6829-C547-BE51-6E539E9AC3AA}"/>
                </a:ext>
              </a:extLst>
            </p:cNvPr>
            <p:cNvSpPr txBox="1"/>
            <p:nvPr/>
          </p:nvSpPr>
          <p:spPr>
            <a:xfrm>
              <a:off x="4361284" y="1878476"/>
              <a:ext cx="9627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etastatic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6E72D67-6502-2348-96EF-C4CEF5911BB0}"/>
                </a:ext>
              </a:extLst>
            </p:cNvPr>
            <p:cNvSpPr txBox="1"/>
            <p:nvPr/>
          </p:nvSpPr>
          <p:spPr>
            <a:xfrm>
              <a:off x="3204709" y="1878477"/>
              <a:ext cx="12246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rimary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DFAE37E-48D6-124C-A913-6E8A16926BBC}"/>
                </a:ext>
              </a:extLst>
            </p:cNvPr>
            <p:cNvSpPr txBox="1"/>
            <p:nvPr/>
          </p:nvSpPr>
          <p:spPr>
            <a:xfrm>
              <a:off x="1918721" y="1872552"/>
              <a:ext cx="12246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ormal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08E553B-464A-5D4B-93C5-A136A5ADA33D}"/>
                </a:ext>
              </a:extLst>
            </p:cNvPr>
            <p:cNvSpPr txBox="1"/>
            <p:nvPr/>
          </p:nvSpPr>
          <p:spPr>
            <a:xfrm>
              <a:off x="623530" y="1866765"/>
              <a:ext cx="12246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MC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0F9BC5E0-F100-7845-B764-BEAE127D9A31}"/>
              </a:ext>
            </a:extLst>
          </p:cNvPr>
          <p:cNvGrpSpPr/>
          <p:nvPr/>
        </p:nvGrpSpPr>
        <p:grpSpPr>
          <a:xfrm>
            <a:off x="258243" y="4509350"/>
            <a:ext cx="3088779" cy="3349751"/>
            <a:chOff x="298656" y="3816852"/>
            <a:chExt cx="3088779" cy="3349751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F9FD89DF-1B1F-234F-8F04-1F58AE10804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8656" y="4077824"/>
              <a:ext cx="3088779" cy="3088779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5A2CAA7-FB46-D04B-BFC3-250B15C10FF0}"/>
                </a:ext>
              </a:extLst>
            </p:cNvPr>
            <p:cNvSpPr txBox="1"/>
            <p:nvPr/>
          </p:nvSpPr>
          <p:spPr>
            <a:xfrm>
              <a:off x="410229" y="4983728"/>
              <a:ext cx="5757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Gzm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B338849-05DC-694D-ADBF-A28B9E76F5EF}"/>
                </a:ext>
              </a:extLst>
            </p:cNvPr>
            <p:cNvSpPr txBox="1"/>
            <p:nvPr/>
          </p:nvSpPr>
          <p:spPr>
            <a:xfrm>
              <a:off x="385383" y="3830416"/>
              <a:ext cx="6174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hi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DF33B5A-7923-5C44-8C72-2CA91CFB90B6}"/>
                </a:ext>
              </a:extLst>
            </p:cNvPr>
            <p:cNvSpPr txBox="1"/>
            <p:nvPr/>
          </p:nvSpPr>
          <p:spPr>
            <a:xfrm>
              <a:off x="1552696" y="3830416"/>
              <a:ext cx="6174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lo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A632346-F636-0E49-8EF0-1AF8CD6DE8DC}"/>
                </a:ext>
              </a:extLst>
            </p:cNvPr>
            <p:cNvSpPr txBox="1"/>
            <p:nvPr/>
          </p:nvSpPr>
          <p:spPr>
            <a:xfrm>
              <a:off x="2629903" y="3816852"/>
              <a:ext cx="7425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neg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6525A7A-13A0-BE4C-8D73-8CCDD47915D4}"/>
                </a:ext>
              </a:extLst>
            </p:cNvPr>
            <p:cNvSpPr txBox="1"/>
            <p:nvPr/>
          </p:nvSpPr>
          <p:spPr>
            <a:xfrm>
              <a:off x="1614457" y="5000643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0FF449A-0375-BD4A-881B-3797C3C276BC}"/>
                </a:ext>
              </a:extLst>
            </p:cNvPr>
            <p:cNvSpPr txBox="1"/>
            <p:nvPr/>
          </p:nvSpPr>
          <p:spPr>
            <a:xfrm>
              <a:off x="2735077" y="4983727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-1BB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7AD7B54-B559-EA4B-A7AC-DA1AAEC5E868}"/>
                </a:ext>
              </a:extLst>
            </p:cNvPr>
            <p:cNvSpPr txBox="1"/>
            <p:nvPr/>
          </p:nvSpPr>
          <p:spPr>
            <a:xfrm>
              <a:off x="446969" y="6132840"/>
              <a:ext cx="5293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COS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A27FCF6-64F3-0048-B650-E5E4666E7201}"/>
                </a:ext>
              </a:extLst>
            </p:cNvPr>
            <p:cNvSpPr txBox="1"/>
            <p:nvPr/>
          </p:nvSpPr>
          <p:spPr>
            <a:xfrm>
              <a:off x="1543270" y="6132839"/>
              <a:ext cx="67197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TLA-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5AD1B1A-FECD-C64C-85EB-FBE54A4E6AA8}"/>
                </a:ext>
              </a:extLst>
            </p:cNvPr>
            <p:cNvSpPr txBox="1"/>
            <p:nvPr/>
          </p:nvSpPr>
          <p:spPr>
            <a:xfrm>
              <a:off x="2669739" y="6118524"/>
              <a:ext cx="5517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-3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7FE71A43-D4E8-FC46-B3C1-0D623111D055}"/>
              </a:ext>
            </a:extLst>
          </p:cNvPr>
          <p:cNvGrpSpPr/>
          <p:nvPr/>
        </p:nvGrpSpPr>
        <p:grpSpPr>
          <a:xfrm>
            <a:off x="258243" y="2371670"/>
            <a:ext cx="6504155" cy="1684359"/>
            <a:chOff x="934561" y="330914"/>
            <a:chExt cx="6504155" cy="1684359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267F70E-BFB3-104A-9BFD-B17E0587767A}"/>
                </a:ext>
              </a:extLst>
            </p:cNvPr>
            <p:cNvSpPr txBox="1"/>
            <p:nvPr/>
          </p:nvSpPr>
          <p:spPr>
            <a:xfrm>
              <a:off x="4858541" y="341444"/>
              <a:ext cx="9627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etastati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C353AAA-AAE5-8349-9FA6-6D47D5220A63}"/>
                </a:ext>
              </a:extLst>
            </p:cNvPr>
            <p:cNvSpPr txBox="1"/>
            <p:nvPr/>
          </p:nvSpPr>
          <p:spPr>
            <a:xfrm>
              <a:off x="3728817" y="339838"/>
              <a:ext cx="12246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rimary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16553B3-3D03-D242-AA2E-A5DE13F33113}"/>
                </a:ext>
              </a:extLst>
            </p:cNvPr>
            <p:cNvSpPr txBox="1"/>
            <p:nvPr/>
          </p:nvSpPr>
          <p:spPr>
            <a:xfrm>
              <a:off x="2521328" y="333732"/>
              <a:ext cx="12246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orma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D4BB844-BCAC-584A-8D88-433303454318}"/>
                </a:ext>
              </a:extLst>
            </p:cNvPr>
            <p:cNvSpPr txBox="1"/>
            <p:nvPr/>
          </p:nvSpPr>
          <p:spPr>
            <a:xfrm>
              <a:off x="1238796" y="330914"/>
              <a:ext cx="12246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MC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67D0F66C-B8CE-4F41-9330-8C8D867356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r="51205"/>
            <a:stretch/>
          </p:blipFill>
          <p:spPr>
            <a:xfrm>
              <a:off x="934561" y="640981"/>
              <a:ext cx="1200417" cy="1195174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48D51B63-6B19-BC45-B05E-522F02B756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r="49198"/>
            <a:stretch/>
          </p:blipFill>
          <p:spPr>
            <a:xfrm>
              <a:off x="2225430" y="640981"/>
              <a:ext cx="1249783" cy="1195174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FFE9792C-847B-1049-A3BF-686DA06F22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r="49925"/>
            <a:stretch/>
          </p:blipFill>
          <p:spPr>
            <a:xfrm>
              <a:off x="3474123" y="640981"/>
              <a:ext cx="1231900" cy="1195174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1DC933ED-4F3B-0342-A2A1-4DFEF4A324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52309"/>
            <a:stretch/>
          </p:blipFill>
          <p:spPr>
            <a:xfrm>
              <a:off x="6039319" y="492723"/>
              <a:ext cx="1399397" cy="152255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F7806D45-B25A-A448-A0B2-6CB2CED4C3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20695" y="640981"/>
              <a:ext cx="1255561" cy="1179497"/>
            </a:xfrm>
            <a:prstGeom prst="rect">
              <a:avLst/>
            </a:prstGeom>
          </p:spPr>
        </p:pic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CB8F313E-EAEF-CF4F-9B1F-F5364F715D31}"/>
              </a:ext>
            </a:extLst>
          </p:cNvPr>
          <p:cNvGrpSpPr/>
          <p:nvPr/>
        </p:nvGrpSpPr>
        <p:grpSpPr>
          <a:xfrm>
            <a:off x="3706178" y="4509350"/>
            <a:ext cx="3088779" cy="3344079"/>
            <a:chOff x="-3264271" y="3812060"/>
            <a:chExt cx="3088779" cy="3344079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71BBE4F-67F7-E444-A2A7-4D038E8F3394}"/>
                </a:ext>
              </a:extLst>
            </p:cNvPr>
            <p:cNvSpPr txBox="1"/>
            <p:nvPr/>
          </p:nvSpPr>
          <p:spPr>
            <a:xfrm>
              <a:off x="-3152698" y="4978936"/>
              <a:ext cx="5757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Gzm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81A48C2-B861-5E44-B4A6-6EB4BE3010A9}"/>
                </a:ext>
              </a:extLst>
            </p:cNvPr>
            <p:cNvSpPr txBox="1"/>
            <p:nvPr/>
          </p:nvSpPr>
          <p:spPr>
            <a:xfrm>
              <a:off x="-3177544" y="3825624"/>
              <a:ext cx="6174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hi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41BA2AE-195F-DC44-BB79-5BFBD17CDF45}"/>
                </a:ext>
              </a:extLst>
            </p:cNvPr>
            <p:cNvSpPr txBox="1"/>
            <p:nvPr/>
          </p:nvSpPr>
          <p:spPr>
            <a:xfrm>
              <a:off x="-2010231" y="3825624"/>
              <a:ext cx="6174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lo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416E1FC-A82C-244C-834E-FB032F899D06}"/>
                </a:ext>
              </a:extLst>
            </p:cNvPr>
            <p:cNvSpPr txBox="1"/>
            <p:nvPr/>
          </p:nvSpPr>
          <p:spPr>
            <a:xfrm>
              <a:off x="-933024" y="3812060"/>
              <a:ext cx="7425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neg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456D8A7-9939-BC4D-A19F-B991150782D3}"/>
                </a:ext>
              </a:extLst>
            </p:cNvPr>
            <p:cNvSpPr txBox="1"/>
            <p:nvPr/>
          </p:nvSpPr>
          <p:spPr>
            <a:xfrm>
              <a:off x="-1948470" y="4995851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E1D6639-3F6A-BD42-8D6B-84CDCC635801}"/>
                </a:ext>
              </a:extLst>
            </p:cNvPr>
            <p:cNvSpPr txBox="1"/>
            <p:nvPr/>
          </p:nvSpPr>
          <p:spPr>
            <a:xfrm>
              <a:off x="-827850" y="4978935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-1BB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67C0BCC-AE7C-C64D-BC13-C8AD5032729F}"/>
                </a:ext>
              </a:extLst>
            </p:cNvPr>
            <p:cNvSpPr txBox="1"/>
            <p:nvPr/>
          </p:nvSpPr>
          <p:spPr>
            <a:xfrm>
              <a:off x="-3115958" y="6128048"/>
              <a:ext cx="5293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COS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B4145C6-02B2-8944-920B-2D3691D022ED}"/>
                </a:ext>
              </a:extLst>
            </p:cNvPr>
            <p:cNvSpPr txBox="1"/>
            <p:nvPr/>
          </p:nvSpPr>
          <p:spPr>
            <a:xfrm>
              <a:off x="-2019657" y="6128047"/>
              <a:ext cx="67197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TLA-4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E4B3EEF-9879-1849-A8F0-5446FBD48250}"/>
                </a:ext>
              </a:extLst>
            </p:cNvPr>
            <p:cNvSpPr txBox="1"/>
            <p:nvPr/>
          </p:nvSpPr>
          <p:spPr>
            <a:xfrm>
              <a:off x="-893188" y="6113732"/>
              <a:ext cx="5517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-3</a:t>
              </a:r>
            </a:p>
          </p:txBody>
        </p:sp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54AF1D11-0BCE-C449-80CB-15C4F674D0B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-3264271" y="4067360"/>
              <a:ext cx="3088779" cy="3088779"/>
            </a:xfrm>
            <a:prstGeom prst="rect">
              <a:avLst/>
            </a:prstGeom>
          </p:spPr>
        </p:pic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62B174C6-B6B7-434B-AFAE-592803D55DD3}"/>
              </a:ext>
            </a:extLst>
          </p:cNvPr>
          <p:cNvSpPr txBox="1"/>
          <p:nvPr/>
        </p:nvSpPr>
        <p:spPr>
          <a:xfrm>
            <a:off x="217929" y="314621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4365987-EC77-8145-9B50-8F6177219327}"/>
              </a:ext>
            </a:extLst>
          </p:cNvPr>
          <p:cNvSpPr txBox="1"/>
          <p:nvPr/>
        </p:nvSpPr>
        <p:spPr>
          <a:xfrm>
            <a:off x="181602" y="217072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809C845-8727-3942-BAB2-595046B8A842}"/>
              </a:ext>
            </a:extLst>
          </p:cNvPr>
          <p:cNvSpPr txBox="1"/>
          <p:nvPr/>
        </p:nvSpPr>
        <p:spPr>
          <a:xfrm>
            <a:off x="1600980" y="4201573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8DD6B35-A445-344B-8404-40F78F425F9F}"/>
              </a:ext>
            </a:extLst>
          </p:cNvPr>
          <p:cNvSpPr txBox="1"/>
          <p:nvPr/>
        </p:nvSpPr>
        <p:spPr>
          <a:xfrm>
            <a:off x="5014911" y="4211478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C3374D8-28B8-A447-A5C3-536DEDB5387A}"/>
              </a:ext>
            </a:extLst>
          </p:cNvPr>
          <p:cNvSpPr txBox="1"/>
          <p:nvPr/>
        </p:nvSpPr>
        <p:spPr>
          <a:xfrm>
            <a:off x="0" y="15648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1E600B6-1929-8E43-9FB7-7C6527319025}"/>
              </a:ext>
            </a:extLst>
          </p:cNvPr>
          <p:cNvSpPr txBox="1"/>
          <p:nvPr/>
        </p:nvSpPr>
        <p:spPr>
          <a:xfrm>
            <a:off x="-46649" y="418495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064A4CC-0D8D-4B11-BE68-D4BA9FAD3C7E}"/>
              </a:ext>
            </a:extLst>
          </p:cNvPr>
          <p:cNvSpPr txBox="1"/>
          <p:nvPr/>
        </p:nvSpPr>
        <p:spPr>
          <a:xfrm>
            <a:off x="5608927" y="14820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626815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33</TotalTime>
  <Words>37</Words>
  <Application>Microsoft Office PowerPoint</Application>
  <PresentationFormat>A4 Paper (210x297 mm)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g, Sophia</dc:creator>
  <cp:lastModifiedBy>Meyer, Tim</cp:lastModifiedBy>
  <cp:revision>118</cp:revision>
  <cp:lastPrinted>2022-01-14T11:12:42Z</cp:lastPrinted>
  <dcterms:created xsi:type="dcterms:W3CDTF">2020-05-29T09:28:48Z</dcterms:created>
  <dcterms:modified xsi:type="dcterms:W3CDTF">2022-03-09T17:56:53Z</dcterms:modified>
</cp:coreProperties>
</file>